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96379-63F4-4784-80BA-5A248508A2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AD1393-0E08-4F6B-9513-521FD9449D1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0B55BD-EEF9-4EA1-851F-36EF138D9A0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4D2ED-B706-4DE2-BAD4-828EB4E64A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2545E-384E-4DBF-8E46-CE3B47DA2E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069BEC-6B11-4136-B11E-98D7793B5E2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41E0FD-3C98-40F9-9651-685DE99663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160E46-D936-42A4-BEFC-DEE93B4DC8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9C67F9-AA78-4045-8845-05FC415752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8C22D-C1E8-4535-87BF-43318CA8CD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04F6C-D072-4387-8730-97843F44C7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BBC5CA-6B2B-47E1-BEAB-D5761F482F5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6810688-73B7-4FFA-8D93-CBCCBBC292F9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物件 5"/>
          <p:cNvGraphicFramePr/>
          <p:nvPr/>
        </p:nvGraphicFramePr>
        <p:xfrm>
          <a:off x="1116000" y="3286080"/>
          <a:ext cx="3743280" cy="2664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物件 5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116000" y="3286080"/>
                    <a:ext cx="3743280" cy="2664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物件 6"/>
          <p:cNvGraphicFramePr/>
          <p:nvPr/>
        </p:nvGraphicFramePr>
        <p:xfrm>
          <a:off x="1108080" y="765000"/>
          <a:ext cx="3247920" cy="273528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物件 6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1108080" y="765000"/>
                    <a:ext cx="3247920" cy="2735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物件 1"/>
          <p:cNvGraphicFramePr/>
          <p:nvPr/>
        </p:nvGraphicFramePr>
        <p:xfrm>
          <a:off x="4500720" y="2205000"/>
          <a:ext cx="3527280" cy="273672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6" name="物件 1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4500720" y="2205000"/>
                    <a:ext cx="3527280" cy="2736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矩形 1"/>
          <p:cNvSpPr/>
          <p:nvPr/>
        </p:nvSpPr>
        <p:spPr>
          <a:xfrm>
            <a:off x="108000" y="5889600"/>
            <a:ext cx="878508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 1 (S1)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VO dose-dependently inhibits the viability of human RCC cells including ACHN, 786-O, and Caki-1. Cells were treated with indicated concentrations of EVO for 12 h, and viability of cells was examined by MTT assay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9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26T05:28:30Z</dcterms:created>
  <dc:creator>Hsin</dc:creator>
  <dc:description/>
  <dc:language>en-US</dc:language>
  <cp:lastModifiedBy>tmu</cp:lastModifiedBy>
  <cp:lastPrinted>2015-04-01T15:34:44Z</cp:lastPrinted>
  <dcterms:modified xsi:type="dcterms:W3CDTF">2016-07-25T15:36:22Z</dcterms:modified>
  <cp:revision>331</cp:revision>
  <dc:subject/>
  <dc:title>投影片 1</dc:title>
</cp:coreProperties>
</file>